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8" d="100"/>
          <a:sy n="58" d="100"/>
        </p:scale>
        <p:origin x="25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24330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3903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61662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1398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11214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01600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34919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6027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18696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6611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27805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8131B2-8426-410E-A0E1-AF9754D30243}" type="datetimeFigureOut">
              <a:rPr lang="en-ZA" smtClean="0"/>
              <a:t>2018/11/0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6DEB1-90B7-4F8A-90E1-3FC717D8C87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46693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E4D7A5F-9512-4407-BC5E-FCB513704788}"/>
              </a:ext>
            </a:extLst>
          </p:cNvPr>
          <p:cNvSpPr/>
          <p:nvPr/>
        </p:nvSpPr>
        <p:spPr>
          <a:xfrm>
            <a:off x="831573" y="948022"/>
            <a:ext cx="5194853" cy="31786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escription:  tr|A2T003_RVFV NP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atabase: </a:t>
            </a:r>
            <a:r>
              <a:rPr lang="en-GB" sz="1200" b="1" dirty="0" err="1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Bunyaviridae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Score: 1094.60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overage %: 87.35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Unique peptides: 264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axonomy:  Rift Valley fever nucleocapsid protein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 </a:t>
            </a:r>
            <a:endParaRPr lang="en-ZA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DNYQEL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IQFAAQAVD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N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IEQWV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E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FAYQGFDA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R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VIELLK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Q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YGGADWEK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DAKK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IVLALT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NKPRRMMMKMS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KEGKATVEALINK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YK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LKEGNPSRDELTLS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VAAALAGWTCQALVVLSEWLPVTGTTMDGLSPAYPRH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MMHPSFAGMVDPSLPEDYL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ILDAHSLYLLQFSRVINPNLR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RT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KEEVAATFTQPMNAAVNSNFISHEK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RREFLK</a:t>
            </a:r>
            <a:r>
              <a:rPr lang="en-GB" sz="1200" b="1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FGLVDSNGKPSAAVMAAAQAYK</a:t>
            </a:r>
            <a:r>
              <a:rPr lang="en-GB" sz="1200" b="1" dirty="0"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AA*</a:t>
            </a:r>
            <a:endParaRPr lang="en-ZA" sz="12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5694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8</TotalTime>
  <Words>28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swa</dc:creator>
  <cp:lastModifiedBy>Ann Meyers</cp:lastModifiedBy>
  <cp:revision>19</cp:revision>
  <cp:lastPrinted>2018-05-11T07:14:11Z</cp:lastPrinted>
  <dcterms:created xsi:type="dcterms:W3CDTF">2017-11-15T10:02:34Z</dcterms:created>
  <dcterms:modified xsi:type="dcterms:W3CDTF">2018-11-02T05:12:25Z</dcterms:modified>
</cp:coreProperties>
</file>